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4" autoAdjust="0"/>
    <p:restoredTop sz="94660"/>
  </p:normalViewPr>
  <p:slideViewPr>
    <p:cSldViewPr snapToGrid="0">
      <p:cViewPr varScale="1">
        <p:scale>
          <a:sx n="84" d="100"/>
          <a:sy n="84" d="100"/>
        </p:scale>
        <p:origin x="9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A28FF3DD-566F-4886-9BA9-C739EF39EBC2}" type="doc">
      <dgm:prSet loTypeId="urn:microsoft.com/office/officeart/2005/8/layout/pyramid2" loCatId="pyramid" qsTypeId="urn:microsoft.com/office/officeart/2005/8/quickstyle/simple1" qsCatId="simple" csTypeId="urn:microsoft.com/office/officeart/2005/8/colors/accent1_2" csCatId="accent1" phldr="1"/>
      <dgm:spPr/>
    </dgm:pt>
    <dgm:pt modelId="{1D1BD3A3-D5CB-40A8-83C8-7F3E688ACBF4}">
      <dgm:prSet phldrT="[Text]"/>
      <dgm:spPr>
        <a:ln>
          <a:solidFill>
            <a:schemeClr val="bg2">
              <a:lumMod val="50000"/>
            </a:schemeClr>
          </a:solidFill>
        </a:ln>
      </dgm:spPr>
      <dgm:t>
        <a:bodyPr/>
        <a:lstStyle/>
        <a:p>
          <a:r>
            <a:rPr lang="de-DE" b="0" dirty="0"/>
            <a:t>Integration of HiBiT </a:t>
          </a:r>
          <a:r>
            <a:rPr lang="de-DE" b="0" dirty="0" err="1"/>
            <a:t>tagged</a:t>
          </a:r>
          <a:r>
            <a:rPr lang="de-DE" b="0" dirty="0"/>
            <a:t> collagen with secretion signal from </a:t>
          </a:r>
          <a:r>
            <a:rPr lang="de-DE" b="0" i="1" dirty="0"/>
            <a:t>pgxA</a:t>
          </a:r>
          <a:r>
            <a:rPr lang="de-DE" b="0" dirty="0"/>
            <a:t> and P4H variant</a:t>
          </a:r>
          <a:endParaRPr lang="en-AU" b="0" dirty="0"/>
        </a:p>
      </dgm:t>
    </dgm:pt>
    <dgm:pt modelId="{B1102DFF-37DD-4121-9FED-477BD09CB9FA}" type="parTrans" cxnId="{9C15D7E9-99F1-46DB-962C-097120455CBB}">
      <dgm:prSet/>
      <dgm:spPr/>
      <dgm:t>
        <a:bodyPr/>
        <a:lstStyle/>
        <a:p>
          <a:endParaRPr lang="en-AU"/>
        </a:p>
      </dgm:t>
    </dgm:pt>
    <dgm:pt modelId="{933378AE-0A7C-4CE7-9D74-B5A1ECFFC86C}" type="sibTrans" cxnId="{9C15D7E9-99F1-46DB-962C-097120455CBB}">
      <dgm:prSet/>
      <dgm:spPr/>
      <dgm:t>
        <a:bodyPr/>
        <a:lstStyle/>
        <a:p>
          <a:endParaRPr lang="en-AU"/>
        </a:p>
      </dgm:t>
    </dgm:pt>
    <dgm:pt modelId="{1883E51C-5D80-4EF1-9437-931EE7B6B0BD}">
      <dgm:prSet phldrT="[Text]"/>
      <dgm:spPr>
        <a:ln>
          <a:solidFill>
            <a:schemeClr val="bg2">
              <a:lumMod val="50000"/>
            </a:schemeClr>
          </a:solidFill>
        </a:ln>
      </dgm:spPr>
      <dgm:t>
        <a:bodyPr/>
        <a:lstStyle/>
        <a:p>
          <a:r>
            <a:rPr lang="de-DE" b="0" dirty="0"/>
            <a:t>Media optimisation paired to genetic alterations </a:t>
          </a:r>
          <a:endParaRPr lang="en-AU" b="0" dirty="0"/>
        </a:p>
      </dgm:t>
    </dgm:pt>
    <dgm:pt modelId="{CB2021DA-D7E8-46EE-B4F2-336093A5CF76}" type="parTrans" cxnId="{8924C87B-22C1-4623-92C2-5C183A00E726}">
      <dgm:prSet/>
      <dgm:spPr/>
      <dgm:t>
        <a:bodyPr/>
        <a:lstStyle/>
        <a:p>
          <a:endParaRPr lang="en-AU"/>
        </a:p>
      </dgm:t>
    </dgm:pt>
    <dgm:pt modelId="{C2DA5EB2-1DFA-4F10-982F-3C302FDD5BFF}" type="sibTrans" cxnId="{8924C87B-22C1-4623-92C2-5C183A00E726}">
      <dgm:prSet/>
      <dgm:spPr/>
      <dgm:t>
        <a:bodyPr/>
        <a:lstStyle/>
        <a:p>
          <a:endParaRPr lang="en-AU"/>
        </a:p>
      </dgm:t>
    </dgm:pt>
    <dgm:pt modelId="{37FC4A54-02E4-46B7-AF55-ACFF3FF8C2CF}">
      <dgm:prSet phldrT="[Text]"/>
      <dgm:spPr>
        <a:ln>
          <a:solidFill>
            <a:schemeClr val="bg2">
              <a:lumMod val="50000"/>
            </a:schemeClr>
          </a:solidFill>
        </a:ln>
      </dgm:spPr>
      <dgm:t>
        <a:bodyPr/>
        <a:lstStyle/>
        <a:p>
          <a:r>
            <a:rPr lang="de-DE" b="1" dirty="0"/>
            <a:t>TM44.2 secreting partially hydroxylated collagen</a:t>
          </a:r>
          <a:endParaRPr lang="en-AU" b="1" dirty="0"/>
        </a:p>
      </dgm:t>
    </dgm:pt>
    <dgm:pt modelId="{AEAFE52F-7A60-443D-8232-54803A7D47B7}" type="parTrans" cxnId="{81A4D20E-045D-4051-B91F-AF01287A82B0}">
      <dgm:prSet/>
      <dgm:spPr/>
      <dgm:t>
        <a:bodyPr/>
        <a:lstStyle/>
        <a:p>
          <a:endParaRPr lang="en-AU"/>
        </a:p>
      </dgm:t>
    </dgm:pt>
    <dgm:pt modelId="{B496C272-282D-48B0-AAAC-AFE38822D104}" type="sibTrans" cxnId="{81A4D20E-045D-4051-B91F-AF01287A82B0}">
      <dgm:prSet/>
      <dgm:spPr/>
      <dgm:t>
        <a:bodyPr/>
        <a:lstStyle/>
        <a:p>
          <a:endParaRPr lang="en-AU"/>
        </a:p>
      </dgm:t>
    </dgm:pt>
    <dgm:pt modelId="{536ADCC4-422A-4588-8EE7-39B5CDC7EEA0}">
      <dgm:prSet phldrT="[Text]"/>
      <dgm:spPr>
        <a:ln>
          <a:solidFill>
            <a:schemeClr val="bg2">
              <a:lumMod val="50000"/>
            </a:schemeClr>
          </a:solidFill>
        </a:ln>
      </dgm:spPr>
      <dgm:t>
        <a:bodyPr/>
        <a:lstStyle/>
        <a:p>
          <a:r>
            <a:rPr lang="de-DE" b="0" dirty="0" err="1"/>
            <a:t>Extracellular</a:t>
          </a:r>
          <a:r>
            <a:rPr lang="de-DE" b="0" dirty="0"/>
            <a:t> Protease deficiency</a:t>
          </a:r>
          <a:br>
            <a:rPr lang="de-DE" b="0" dirty="0"/>
          </a:br>
          <a:r>
            <a:rPr lang="de-DE" b="0" i="1" dirty="0"/>
            <a:t>prtT </a:t>
          </a:r>
          <a:r>
            <a:rPr lang="de-DE" b="0" baseline="30000" dirty="0"/>
            <a:t>-</a:t>
          </a:r>
          <a:endParaRPr lang="en-AU" b="0" i="1" baseline="30000" dirty="0"/>
        </a:p>
      </dgm:t>
    </dgm:pt>
    <dgm:pt modelId="{A5E26711-7F68-4153-A6A6-73CBA100EF06}" type="parTrans" cxnId="{067F28D9-BDAD-45FB-8989-065E5564D024}">
      <dgm:prSet/>
      <dgm:spPr/>
      <dgm:t>
        <a:bodyPr/>
        <a:lstStyle/>
        <a:p>
          <a:endParaRPr lang="en-AU"/>
        </a:p>
      </dgm:t>
    </dgm:pt>
    <dgm:pt modelId="{42E5C83B-FF9B-4195-9984-FD2C1BA3B17A}" type="sibTrans" cxnId="{067F28D9-BDAD-45FB-8989-065E5564D024}">
      <dgm:prSet/>
      <dgm:spPr/>
      <dgm:t>
        <a:bodyPr/>
        <a:lstStyle/>
        <a:p>
          <a:endParaRPr lang="en-AU"/>
        </a:p>
      </dgm:t>
    </dgm:pt>
    <dgm:pt modelId="{DAECB515-5936-44EB-AED2-58CD3A3F5BD2}">
      <dgm:prSet phldrT="[Text]"/>
      <dgm:spPr>
        <a:ln>
          <a:solidFill>
            <a:schemeClr val="bg2">
              <a:lumMod val="50000"/>
            </a:schemeClr>
          </a:solidFill>
        </a:ln>
      </dgm:spPr>
      <dgm:t>
        <a:bodyPr/>
        <a:lstStyle/>
        <a:p>
          <a:r>
            <a:rPr lang="de-DE" b="0" i="1" dirty="0"/>
            <a:t>gaaA</a:t>
          </a:r>
          <a:r>
            <a:rPr lang="de-DE" b="0" dirty="0"/>
            <a:t> and </a:t>
          </a:r>
          <a:r>
            <a:rPr lang="de-DE" b="0" i="1" dirty="0"/>
            <a:t>gatA</a:t>
          </a:r>
          <a:r>
            <a:rPr lang="de-DE" b="0" dirty="0"/>
            <a:t> strong expression in </a:t>
          </a:r>
          <a:r>
            <a:rPr lang="de-DE" b="0" dirty="0" err="1"/>
            <a:t>glucose</a:t>
          </a:r>
          <a:r>
            <a:rPr lang="de-DE" b="0" dirty="0"/>
            <a:t> </a:t>
          </a:r>
          <a:r>
            <a:rPr lang="de-DE" b="0" dirty="0" err="1"/>
            <a:t>replete</a:t>
          </a:r>
          <a:r>
            <a:rPr lang="de-DE" b="0" dirty="0"/>
            <a:t> </a:t>
          </a:r>
          <a:r>
            <a:rPr lang="de-DE" b="0" dirty="0" err="1"/>
            <a:t>conditions</a:t>
          </a:r>
          <a:r>
            <a:rPr lang="de-DE" b="0" dirty="0"/>
            <a:t> </a:t>
          </a:r>
          <a:r>
            <a:rPr lang="de-DE" b="0" dirty="0" err="1"/>
            <a:t>with</a:t>
          </a:r>
          <a:r>
            <a:rPr lang="de-DE" b="0" dirty="0"/>
            <a:t> insertion of </a:t>
          </a:r>
          <a:r>
            <a:rPr lang="de-DE" b="0" i="1" dirty="0"/>
            <a:t>httA</a:t>
          </a:r>
          <a:r>
            <a:rPr lang="de-DE" b="0" dirty="0"/>
            <a:t> and </a:t>
          </a:r>
          <a:r>
            <a:rPr lang="de-DE" b="0" i="1" dirty="0"/>
            <a:t>rpl15</a:t>
          </a:r>
          <a:r>
            <a:rPr lang="de-DE" b="0" dirty="0"/>
            <a:t> promoters</a:t>
          </a:r>
          <a:endParaRPr lang="en-AU" b="0" dirty="0"/>
        </a:p>
      </dgm:t>
    </dgm:pt>
    <dgm:pt modelId="{7EB5B04E-5852-4901-AC2F-CD4411D7E2C8}" type="parTrans" cxnId="{802E9459-244F-417C-8F66-3C61246BF7D6}">
      <dgm:prSet/>
      <dgm:spPr/>
      <dgm:t>
        <a:bodyPr/>
        <a:lstStyle/>
        <a:p>
          <a:endParaRPr lang="en-AU"/>
        </a:p>
      </dgm:t>
    </dgm:pt>
    <dgm:pt modelId="{B7E08108-FA06-4A5D-8EEC-D177CDDBC967}" type="sibTrans" cxnId="{802E9459-244F-417C-8F66-3C61246BF7D6}">
      <dgm:prSet/>
      <dgm:spPr/>
      <dgm:t>
        <a:bodyPr/>
        <a:lstStyle/>
        <a:p>
          <a:endParaRPr lang="en-AU"/>
        </a:p>
      </dgm:t>
    </dgm:pt>
    <dgm:pt modelId="{FBE805F3-6CEB-7345-B982-DAF10075203A}">
      <dgm:prSet/>
      <dgm:spPr>
        <a:ln>
          <a:solidFill>
            <a:schemeClr val="bg2">
              <a:lumMod val="50000"/>
            </a:schemeClr>
          </a:solidFill>
        </a:ln>
      </dgm:spPr>
      <dgm:t>
        <a:bodyPr/>
        <a:lstStyle/>
        <a:p>
          <a:r>
            <a:rPr lang="en-GB" dirty="0"/>
            <a:t>Proline specific endopeptidase KO - ∆</a:t>
          </a:r>
          <a:r>
            <a:rPr lang="en-GB" i="1" dirty="0" err="1"/>
            <a:t>protA</a:t>
          </a:r>
          <a:endParaRPr lang="en-GB" i="1" dirty="0"/>
        </a:p>
      </dgm:t>
    </dgm:pt>
    <dgm:pt modelId="{FA95C303-32C4-B44B-A0B8-280F1C0F5719}" type="parTrans" cxnId="{16640AEC-6F3F-AB42-883F-A5FC3244B862}">
      <dgm:prSet/>
      <dgm:spPr/>
      <dgm:t>
        <a:bodyPr/>
        <a:lstStyle/>
        <a:p>
          <a:endParaRPr lang="en-GB"/>
        </a:p>
      </dgm:t>
    </dgm:pt>
    <dgm:pt modelId="{C2DF1185-7ADC-D940-85C2-9F7E163F0BD2}" type="sibTrans" cxnId="{16640AEC-6F3F-AB42-883F-A5FC3244B862}">
      <dgm:prSet/>
      <dgm:spPr/>
      <dgm:t>
        <a:bodyPr/>
        <a:lstStyle/>
        <a:p>
          <a:endParaRPr lang="en-GB"/>
        </a:p>
      </dgm:t>
    </dgm:pt>
    <dgm:pt modelId="{C96A36C2-9A9E-481F-85DF-F5B231CA3391}" type="pres">
      <dgm:prSet presAssocID="{A28FF3DD-566F-4886-9BA9-C739EF39EBC2}" presName="compositeShape" presStyleCnt="0">
        <dgm:presLayoutVars>
          <dgm:dir/>
          <dgm:resizeHandles/>
        </dgm:presLayoutVars>
      </dgm:prSet>
      <dgm:spPr/>
    </dgm:pt>
    <dgm:pt modelId="{7468C088-E1F7-4273-8590-49A2B9E44412}" type="pres">
      <dgm:prSet presAssocID="{A28FF3DD-566F-4886-9BA9-C739EF39EBC2}" presName="pyramid" presStyleLbl="node1" presStyleIdx="0" presStyleCnt="1" custAng="10800000" custScaleX="78816" custLinFactNeighborX="4075" custLinFactNeighborY="-744"/>
      <dgm:spPr>
        <a:gradFill flip="none" rotWithShape="1">
          <a:gsLst>
            <a:gs pos="0">
              <a:schemeClr val="bg2">
                <a:lumMod val="75000"/>
                <a:tint val="66000"/>
                <a:satMod val="160000"/>
              </a:schemeClr>
            </a:gs>
            <a:gs pos="36000">
              <a:schemeClr val="bg2">
                <a:lumMod val="75000"/>
                <a:tint val="44500"/>
                <a:satMod val="160000"/>
              </a:schemeClr>
            </a:gs>
            <a:gs pos="66000">
              <a:schemeClr val="bg2">
                <a:lumMod val="50000"/>
              </a:schemeClr>
            </a:gs>
          </a:gsLst>
          <a:lin ang="16200000" scaled="1"/>
          <a:tileRect/>
        </a:gradFill>
      </dgm:spPr>
    </dgm:pt>
    <dgm:pt modelId="{490541F0-9A92-4F6E-8A04-9B400FEC0A76}" type="pres">
      <dgm:prSet presAssocID="{A28FF3DD-566F-4886-9BA9-C739EF39EBC2}" presName="theList" presStyleCnt="0"/>
      <dgm:spPr/>
    </dgm:pt>
    <dgm:pt modelId="{03F6FB4D-74D6-4D09-A246-A9EDD9BDBBC6}" type="pres">
      <dgm:prSet presAssocID="{1D1BD3A3-D5CB-40A8-83C8-7F3E688ACBF4}" presName="aNode" presStyleLbl="fgAcc1" presStyleIdx="0" presStyleCnt="6" custLinFactY="259973" custLinFactNeighborX="1185" custLinFactNeighborY="300000">
        <dgm:presLayoutVars>
          <dgm:bulletEnabled val="1"/>
        </dgm:presLayoutVars>
      </dgm:prSet>
      <dgm:spPr/>
    </dgm:pt>
    <dgm:pt modelId="{8BBEDEF6-3D5B-44B4-8CFC-F40C14280EF9}" type="pres">
      <dgm:prSet presAssocID="{1D1BD3A3-D5CB-40A8-83C8-7F3E688ACBF4}" presName="aSpace" presStyleCnt="0"/>
      <dgm:spPr/>
    </dgm:pt>
    <dgm:pt modelId="{F54266B4-21D4-4D67-AC17-4D151B474E82}" type="pres">
      <dgm:prSet presAssocID="{536ADCC4-422A-4588-8EE7-39B5CDC7EEA0}" presName="aNode" presStyleLbl="fgAcc1" presStyleIdx="1" presStyleCnt="6" custScaleY="67754" custLinFactY="-87720" custLinFactNeighborX="119" custLinFactNeighborY="-100000">
        <dgm:presLayoutVars>
          <dgm:bulletEnabled val="1"/>
        </dgm:presLayoutVars>
      </dgm:prSet>
      <dgm:spPr/>
    </dgm:pt>
    <dgm:pt modelId="{C3513C6B-4862-49CB-B58B-65E02DD951A4}" type="pres">
      <dgm:prSet presAssocID="{536ADCC4-422A-4588-8EE7-39B5CDC7EEA0}" presName="aSpace" presStyleCnt="0"/>
      <dgm:spPr/>
    </dgm:pt>
    <dgm:pt modelId="{FBEF18CA-5EE9-C44E-9CDB-D834333A07F6}" type="pres">
      <dgm:prSet presAssocID="{FBE805F3-6CEB-7345-B982-DAF10075203A}" presName="aNode" presStyleLbl="fgAcc1" presStyleIdx="2" presStyleCnt="6" custScaleX="100000" custScaleY="52707" custLinFactY="-81980" custLinFactNeighborX="935" custLinFactNeighborY="-100000">
        <dgm:presLayoutVars>
          <dgm:bulletEnabled val="1"/>
        </dgm:presLayoutVars>
      </dgm:prSet>
      <dgm:spPr/>
    </dgm:pt>
    <dgm:pt modelId="{EC9D02A3-3403-F045-9700-726D9F31B656}" type="pres">
      <dgm:prSet presAssocID="{FBE805F3-6CEB-7345-B982-DAF10075203A}" presName="aSpace" presStyleCnt="0"/>
      <dgm:spPr/>
    </dgm:pt>
    <dgm:pt modelId="{2ADA30E0-44EF-4039-8B8D-1536EC87986D}" type="pres">
      <dgm:prSet presAssocID="{DAECB515-5936-44EB-AED2-58CD3A3F5BD2}" presName="aNode" presStyleLbl="fgAcc1" presStyleIdx="3" presStyleCnt="6" custLinFactY="-74122" custLinFactNeighborX="1185" custLinFactNeighborY="-100000">
        <dgm:presLayoutVars>
          <dgm:bulletEnabled val="1"/>
        </dgm:presLayoutVars>
      </dgm:prSet>
      <dgm:spPr/>
    </dgm:pt>
    <dgm:pt modelId="{2A5394B3-EBFD-4F7A-BAC4-48F1991818A6}" type="pres">
      <dgm:prSet presAssocID="{DAECB515-5936-44EB-AED2-58CD3A3F5BD2}" presName="aSpace" presStyleCnt="0"/>
      <dgm:spPr/>
    </dgm:pt>
    <dgm:pt modelId="{59DDA59F-5D9B-4A33-B3F7-956DA4A32AEE}" type="pres">
      <dgm:prSet presAssocID="{1883E51C-5D80-4EF1-9437-931EE7B6B0BD}" presName="aNode" presStyleLbl="fgAcc1" presStyleIdx="4" presStyleCnt="6" custScaleY="75723" custLinFactY="40401" custLinFactNeighborX="963" custLinFactNeighborY="100000">
        <dgm:presLayoutVars>
          <dgm:bulletEnabled val="1"/>
        </dgm:presLayoutVars>
      </dgm:prSet>
      <dgm:spPr/>
    </dgm:pt>
    <dgm:pt modelId="{DC0BEDD9-B544-432E-A328-D1FC70E87B26}" type="pres">
      <dgm:prSet presAssocID="{1883E51C-5D80-4EF1-9437-931EE7B6B0BD}" presName="aSpace" presStyleCnt="0"/>
      <dgm:spPr/>
    </dgm:pt>
    <dgm:pt modelId="{D1935EBE-F08B-4A78-A24F-64612CACE637}" type="pres">
      <dgm:prSet presAssocID="{37FC4A54-02E4-46B7-AF55-ACFF3FF8C2CF}" presName="aNode" presStyleLbl="fgAcc1" presStyleIdx="5" presStyleCnt="6" custLinFactY="69005" custLinFactNeighborX="-47424" custLinFactNeighborY="100000">
        <dgm:presLayoutVars>
          <dgm:bulletEnabled val="1"/>
        </dgm:presLayoutVars>
      </dgm:prSet>
      <dgm:spPr/>
    </dgm:pt>
    <dgm:pt modelId="{2525A5DC-ACFA-45BD-8D0B-F21E975C4349}" type="pres">
      <dgm:prSet presAssocID="{37FC4A54-02E4-46B7-AF55-ACFF3FF8C2CF}" presName="aSpace" presStyleCnt="0"/>
      <dgm:spPr/>
    </dgm:pt>
  </dgm:ptLst>
  <dgm:cxnLst>
    <dgm:cxn modelId="{7D8C4100-1B65-884E-82DC-0B3890361B7E}" type="presOf" srcId="{1D1BD3A3-D5CB-40A8-83C8-7F3E688ACBF4}" destId="{03F6FB4D-74D6-4D09-A246-A9EDD9BDBBC6}" srcOrd="0" destOrd="0" presId="urn:microsoft.com/office/officeart/2005/8/layout/pyramid2"/>
    <dgm:cxn modelId="{81A4D20E-045D-4051-B91F-AF01287A82B0}" srcId="{A28FF3DD-566F-4886-9BA9-C739EF39EBC2}" destId="{37FC4A54-02E4-46B7-AF55-ACFF3FF8C2CF}" srcOrd="5" destOrd="0" parTransId="{AEAFE52F-7A60-443D-8232-54803A7D47B7}" sibTransId="{B496C272-282D-48B0-AAAC-AFE38822D104}"/>
    <dgm:cxn modelId="{72DED92A-4877-9943-9387-6E62BD548750}" type="presOf" srcId="{FBE805F3-6CEB-7345-B982-DAF10075203A}" destId="{FBEF18CA-5EE9-C44E-9CDB-D834333A07F6}" srcOrd="0" destOrd="0" presId="urn:microsoft.com/office/officeart/2005/8/layout/pyramid2"/>
    <dgm:cxn modelId="{650EC732-108F-5D43-86E1-BD89FF5EEF04}" type="presOf" srcId="{1883E51C-5D80-4EF1-9437-931EE7B6B0BD}" destId="{59DDA59F-5D9B-4A33-B3F7-956DA4A32AEE}" srcOrd="0" destOrd="0" presId="urn:microsoft.com/office/officeart/2005/8/layout/pyramid2"/>
    <dgm:cxn modelId="{802E9459-244F-417C-8F66-3C61246BF7D6}" srcId="{A28FF3DD-566F-4886-9BA9-C739EF39EBC2}" destId="{DAECB515-5936-44EB-AED2-58CD3A3F5BD2}" srcOrd="3" destOrd="0" parTransId="{7EB5B04E-5852-4901-AC2F-CD4411D7E2C8}" sibTransId="{B7E08108-FA06-4A5D-8EEC-D177CDDBC967}"/>
    <dgm:cxn modelId="{FABB8E5A-56B1-4E7C-834A-4B5401DC7968}" type="presOf" srcId="{A28FF3DD-566F-4886-9BA9-C739EF39EBC2}" destId="{C96A36C2-9A9E-481F-85DF-F5B231CA3391}" srcOrd="0" destOrd="0" presId="urn:microsoft.com/office/officeart/2005/8/layout/pyramid2"/>
    <dgm:cxn modelId="{8924C87B-22C1-4623-92C2-5C183A00E726}" srcId="{A28FF3DD-566F-4886-9BA9-C739EF39EBC2}" destId="{1883E51C-5D80-4EF1-9437-931EE7B6B0BD}" srcOrd="4" destOrd="0" parTransId="{CB2021DA-D7E8-46EE-B4F2-336093A5CF76}" sibTransId="{C2DA5EB2-1DFA-4F10-982F-3C302FDD5BFF}"/>
    <dgm:cxn modelId="{067F28D9-BDAD-45FB-8989-065E5564D024}" srcId="{A28FF3DD-566F-4886-9BA9-C739EF39EBC2}" destId="{536ADCC4-422A-4588-8EE7-39B5CDC7EEA0}" srcOrd="1" destOrd="0" parTransId="{A5E26711-7F68-4153-A6A6-73CBA100EF06}" sibTransId="{42E5C83B-FF9B-4195-9984-FD2C1BA3B17A}"/>
    <dgm:cxn modelId="{34D706E8-B3BC-8446-ACE4-25FA618C6E68}" type="presOf" srcId="{DAECB515-5936-44EB-AED2-58CD3A3F5BD2}" destId="{2ADA30E0-44EF-4039-8B8D-1536EC87986D}" srcOrd="0" destOrd="0" presId="urn:microsoft.com/office/officeart/2005/8/layout/pyramid2"/>
    <dgm:cxn modelId="{9C15D7E9-99F1-46DB-962C-097120455CBB}" srcId="{A28FF3DD-566F-4886-9BA9-C739EF39EBC2}" destId="{1D1BD3A3-D5CB-40A8-83C8-7F3E688ACBF4}" srcOrd="0" destOrd="0" parTransId="{B1102DFF-37DD-4121-9FED-477BD09CB9FA}" sibTransId="{933378AE-0A7C-4CE7-9D74-B5A1ECFFC86C}"/>
    <dgm:cxn modelId="{16640AEC-6F3F-AB42-883F-A5FC3244B862}" srcId="{A28FF3DD-566F-4886-9BA9-C739EF39EBC2}" destId="{FBE805F3-6CEB-7345-B982-DAF10075203A}" srcOrd="2" destOrd="0" parTransId="{FA95C303-32C4-B44B-A0B8-280F1C0F5719}" sibTransId="{C2DF1185-7ADC-D940-85C2-9F7E163F0BD2}"/>
    <dgm:cxn modelId="{45EFC9F4-C873-1E46-B5DA-7D2281B18B83}" type="presOf" srcId="{37FC4A54-02E4-46B7-AF55-ACFF3FF8C2CF}" destId="{D1935EBE-F08B-4A78-A24F-64612CACE637}" srcOrd="0" destOrd="0" presId="urn:microsoft.com/office/officeart/2005/8/layout/pyramid2"/>
    <dgm:cxn modelId="{BC9588F9-1D0C-7548-BF74-E46B24865CA0}" type="presOf" srcId="{536ADCC4-422A-4588-8EE7-39B5CDC7EEA0}" destId="{F54266B4-21D4-4D67-AC17-4D151B474E82}" srcOrd="0" destOrd="0" presId="urn:microsoft.com/office/officeart/2005/8/layout/pyramid2"/>
    <dgm:cxn modelId="{01E8C90A-4588-9448-950E-914E372DF117}" type="presParOf" srcId="{C96A36C2-9A9E-481F-85DF-F5B231CA3391}" destId="{7468C088-E1F7-4273-8590-49A2B9E44412}" srcOrd="0" destOrd="0" presId="urn:microsoft.com/office/officeart/2005/8/layout/pyramid2"/>
    <dgm:cxn modelId="{E5A85FC5-6925-7241-8634-62B801351F45}" type="presParOf" srcId="{C96A36C2-9A9E-481F-85DF-F5B231CA3391}" destId="{490541F0-9A92-4F6E-8A04-9B400FEC0A76}" srcOrd="1" destOrd="0" presId="urn:microsoft.com/office/officeart/2005/8/layout/pyramid2"/>
    <dgm:cxn modelId="{60F28C1D-7164-F644-9660-FCEB5E4638F1}" type="presParOf" srcId="{490541F0-9A92-4F6E-8A04-9B400FEC0A76}" destId="{03F6FB4D-74D6-4D09-A246-A9EDD9BDBBC6}" srcOrd="0" destOrd="0" presId="urn:microsoft.com/office/officeart/2005/8/layout/pyramid2"/>
    <dgm:cxn modelId="{FC7A5B36-8348-504F-8469-085C8D9511D0}" type="presParOf" srcId="{490541F0-9A92-4F6E-8A04-9B400FEC0A76}" destId="{8BBEDEF6-3D5B-44B4-8CFC-F40C14280EF9}" srcOrd="1" destOrd="0" presId="urn:microsoft.com/office/officeart/2005/8/layout/pyramid2"/>
    <dgm:cxn modelId="{77B0CECF-2247-7D4C-807C-1FBCC84BE655}" type="presParOf" srcId="{490541F0-9A92-4F6E-8A04-9B400FEC0A76}" destId="{F54266B4-21D4-4D67-AC17-4D151B474E82}" srcOrd="2" destOrd="0" presId="urn:microsoft.com/office/officeart/2005/8/layout/pyramid2"/>
    <dgm:cxn modelId="{39E3D840-F05B-DE46-B820-1CACB257B6BF}" type="presParOf" srcId="{490541F0-9A92-4F6E-8A04-9B400FEC0A76}" destId="{C3513C6B-4862-49CB-B58B-65E02DD951A4}" srcOrd="3" destOrd="0" presId="urn:microsoft.com/office/officeart/2005/8/layout/pyramid2"/>
    <dgm:cxn modelId="{14BD4A23-8F46-EE46-8106-544FBFC599DC}" type="presParOf" srcId="{490541F0-9A92-4F6E-8A04-9B400FEC0A76}" destId="{FBEF18CA-5EE9-C44E-9CDB-D834333A07F6}" srcOrd="4" destOrd="0" presId="urn:microsoft.com/office/officeart/2005/8/layout/pyramid2"/>
    <dgm:cxn modelId="{EACD03DA-F02B-DF41-8816-A53EB2763AD9}" type="presParOf" srcId="{490541F0-9A92-4F6E-8A04-9B400FEC0A76}" destId="{EC9D02A3-3403-F045-9700-726D9F31B656}" srcOrd="5" destOrd="0" presId="urn:microsoft.com/office/officeart/2005/8/layout/pyramid2"/>
    <dgm:cxn modelId="{E0C5D731-5914-6440-9200-83B2E08D69A5}" type="presParOf" srcId="{490541F0-9A92-4F6E-8A04-9B400FEC0A76}" destId="{2ADA30E0-44EF-4039-8B8D-1536EC87986D}" srcOrd="6" destOrd="0" presId="urn:microsoft.com/office/officeart/2005/8/layout/pyramid2"/>
    <dgm:cxn modelId="{308F8FA5-D6AD-264C-B535-510F1D340DF0}" type="presParOf" srcId="{490541F0-9A92-4F6E-8A04-9B400FEC0A76}" destId="{2A5394B3-EBFD-4F7A-BAC4-48F1991818A6}" srcOrd="7" destOrd="0" presId="urn:microsoft.com/office/officeart/2005/8/layout/pyramid2"/>
    <dgm:cxn modelId="{CC4CED86-CAEB-7740-BD3A-93FDF7A8FF78}" type="presParOf" srcId="{490541F0-9A92-4F6E-8A04-9B400FEC0A76}" destId="{59DDA59F-5D9B-4A33-B3F7-956DA4A32AEE}" srcOrd="8" destOrd="0" presId="urn:microsoft.com/office/officeart/2005/8/layout/pyramid2"/>
    <dgm:cxn modelId="{555F0F4D-2B3F-F040-9B6D-466DDE217CDB}" type="presParOf" srcId="{490541F0-9A92-4F6E-8A04-9B400FEC0A76}" destId="{DC0BEDD9-B544-432E-A328-D1FC70E87B26}" srcOrd="9" destOrd="0" presId="urn:microsoft.com/office/officeart/2005/8/layout/pyramid2"/>
    <dgm:cxn modelId="{982EE83E-25B7-AE4E-B16D-4EF72746F370}" type="presParOf" srcId="{490541F0-9A92-4F6E-8A04-9B400FEC0A76}" destId="{D1935EBE-F08B-4A78-A24F-64612CACE637}" srcOrd="10" destOrd="0" presId="urn:microsoft.com/office/officeart/2005/8/layout/pyramid2"/>
    <dgm:cxn modelId="{AAEE0E73-68AD-054F-9D00-EDC44FF21034}" type="presParOf" srcId="{490541F0-9A92-4F6E-8A04-9B400FEC0A76}" destId="{2525A5DC-ACFA-45BD-8D0B-F21E975C4349}" srcOrd="11" destOrd="0" presId="urn:microsoft.com/office/officeart/2005/8/layout/pyramid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7468C088-E1F7-4273-8590-49A2B9E44412}">
      <dsp:nvSpPr>
        <dsp:cNvPr id="0" name=""/>
        <dsp:cNvSpPr/>
      </dsp:nvSpPr>
      <dsp:spPr>
        <a:xfrm rot="10800000">
          <a:off x="627456" y="0"/>
          <a:ext cx="1438817" cy="4710392"/>
        </a:xfrm>
        <a:prstGeom prst="triangle">
          <a:avLst/>
        </a:prstGeom>
        <a:gradFill flip="none" rotWithShape="1">
          <a:gsLst>
            <a:gs pos="0">
              <a:schemeClr val="bg2">
                <a:lumMod val="75000"/>
                <a:tint val="66000"/>
                <a:satMod val="160000"/>
              </a:schemeClr>
            </a:gs>
            <a:gs pos="36000">
              <a:schemeClr val="bg2">
                <a:lumMod val="75000"/>
                <a:tint val="44500"/>
                <a:satMod val="160000"/>
              </a:schemeClr>
            </a:gs>
            <a:gs pos="66000">
              <a:schemeClr val="bg2">
                <a:lumMod val="50000"/>
              </a:schemeClr>
            </a:gs>
          </a:gsLst>
          <a:lin ang="16200000" scaled="1"/>
          <a:tileRect/>
        </a:gra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03F6FB4D-74D6-4D09-A246-A9EDD9BDBBC6}">
      <dsp:nvSpPr>
        <dsp:cNvPr id="0" name=""/>
        <dsp:cNvSpPr/>
      </dsp:nvSpPr>
      <dsp:spPr>
        <a:xfrm>
          <a:off x="1286535" y="2433568"/>
          <a:ext cx="1186600" cy="659639"/>
        </a:xfrm>
        <a:prstGeom prst="round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bg2">
              <a:lumMod val="50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6670" tIns="26670" rIns="26670" bIns="26670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700" b="0" kern="1200" dirty="0"/>
            <a:t>Integration of HiBiT </a:t>
          </a:r>
          <a:r>
            <a:rPr lang="de-DE" sz="700" b="0" kern="1200" dirty="0" err="1"/>
            <a:t>tagged</a:t>
          </a:r>
          <a:r>
            <a:rPr lang="de-DE" sz="700" b="0" kern="1200" dirty="0"/>
            <a:t> collagen with secretion signal from </a:t>
          </a:r>
          <a:r>
            <a:rPr lang="de-DE" sz="700" b="0" i="1" kern="1200" dirty="0"/>
            <a:t>pgxA</a:t>
          </a:r>
          <a:r>
            <a:rPr lang="de-DE" sz="700" b="0" kern="1200" dirty="0"/>
            <a:t> and P4H variant</a:t>
          </a:r>
          <a:endParaRPr lang="en-AU" sz="700" b="0" kern="1200" dirty="0"/>
        </a:p>
      </dsp:txBody>
      <dsp:txXfrm>
        <a:off x="1318736" y="2465769"/>
        <a:ext cx="1122198" cy="595237"/>
      </dsp:txXfrm>
    </dsp:sp>
    <dsp:sp modelId="{F54266B4-21D4-4D67-AC17-4D151B474E82}">
      <dsp:nvSpPr>
        <dsp:cNvPr id="0" name=""/>
        <dsp:cNvSpPr/>
      </dsp:nvSpPr>
      <dsp:spPr>
        <a:xfrm>
          <a:off x="1273886" y="552323"/>
          <a:ext cx="1186600" cy="446931"/>
        </a:xfrm>
        <a:prstGeom prst="round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bg2">
              <a:lumMod val="50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6670" tIns="26670" rIns="26670" bIns="26670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700" b="0" kern="1200" dirty="0" err="1"/>
            <a:t>Extracellular</a:t>
          </a:r>
          <a:r>
            <a:rPr lang="de-DE" sz="700" b="0" kern="1200" dirty="0"/>
            <a:t> Protease deficiency</a:t>
          </a:r>
          <a:br>
            <a:rPr lang="de-DE" sz="700" b="0" kern="1200" dirty="0"/>
          </a:br>
          <a:r>
            <a:rPr lang="de-DE" sz="700" b="0" i="1" kern="1200" dirty="0"/>
            <a:t>prtT </a:t>
          </a:r>
          <a:r>
            <a:rPr lang="de-DE" sz="700" b="0" kern="1200" baseline="30000" dirty="0"/>
            <a:t>-</a:t>
          </a:r>
          <a:endParaRPr lang="en-AU" sz="700" b="0" i="1" kern="1200" baseline="30000" dirty="0"/>
        </a:p>
      </dsp:txBody>
      <dsp:txXfrm>
        <a:off x="1295703" y="574140"/>
        <a:ext cx="1142966" cy="403297"/>
      </dsp:txXfrm>
    </dsp:sp>
    <dsp:sp modelId="{FBEF18CA-5EE9-C44E-9CDB-D834333A07F6}">
      <dsp:nvSpPr>
        <dsp:cNvPr id="0" name=""/>
        <dsp:cNvSpPr/>
      </dsp:nvSpPr>
      <dsp:spPr>
        <a:xfrm>
          <a:off x="1283568" y="1119573"/>
          <a:ext cx="1186600" cy="347675"/>
        </a:xfrm>
        <a:prstGeom prst="round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bg2">
              <a:lumMod val="50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6670" tIns="26670" rIns="26670" bIns="26670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700" kern="1200" dirty="0"/>
            <a:t>Proline specific endopeptidase KO - ∆</a:t>
          </a:r>
          <a:r>
            <a:rPr lang="en-GB" sz="700" i="1" kern="1200" dirty="0" err="1"/>
            <a:t>protA</a:t>
          </a:r>
          <a:endParaRPr lang="en-GB" sz="700" i="1" kern="1200" dirty="0"/>
        </a:p>
      </dsp:txBody>
      <dsp:txXfrm>
        <a:off x="1300540" y="1136545"/>
        <a:ext cx="1152656" cy="313731"/>
      </dsp:txXfrm>
    </dsp:sp>
    <dsp:sp modelId="{2ADA30E0-44EF-4039-8B8D-1536EC87986D}">
      <dsp:nvSpPr>
        <dsp:cNvPr id="0" name=""/>
        <dsp:cNvSpPr/>
      </dsp:nvSpPr>
      <dsp:spPr>
        <a:xfrm>
          <a:off x="1286535" y="1601539"/>
          <a:ext cx="1186600" cy="659639"/>
        </a:xfrm>
        <a:prstGeom prst="round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bg2">
              <a:lumMod val="50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6670" tIns="26670" rIns="26670" bIns="26670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700" b="0" i="1" kern="1200" dirty="0"/>
            <a:t>gaaA</a:t>
          </a:r>
          <a:r>
            <a:rPr lang="de-DE" sz="700" b="0" kern="1200" dirty="0"/>
            <a:t> and </a:t>
          </a:r>
          <a:r>
            <a:rPr lang="de-DE" sz="700" b="0" i="1" kern="1200" dirty="0"/>
            <a:t>gatA</a:t>
          </a:r>
          <a:r>
            <a:rPr lang="de-DE" sz="700" b="0" kern="1200" dirty="0"/>
            <a:t> strong expression in </a:t>
          </a:r>
          <a:r>
            <a:rPr lang="de-DE" sz="700" b="0" kern="1200" dirty="0" err="1"/>
            <a:t>glucose</a:t>
          </a:r>
          <a:r>
            <a:rPr lang="de-DE" sz="700" b="0" kern="1200" dirty="0"/>
            <a:t> </a:t>
          </a:r>
          <a:r>
            <a:rPr lang="de-DE" sz="700" b="0" kern="1200" dirty="0" err="1"/>
            <a:t>replete</a:t>
          </a:r>
          <a:r>
            <a:rPr lang="de-DE" sz="700" b="0" kern="1200" dirty="0"/>
            <a:t> </a:t>
          </a:r>
          <a:r>
            <a:rPr lang="de-DE" sz="700" b="0" kern="1200" dirty="0" err="1"/>
            <a:t>conditions</a:t>
          </a:r>
          <a:r>
            <a:rPr lang="de-DE" sz="700" b="0" kern="1200" dirty="0"/>
            <a:t> </a:t>
          </a:r>
          <a:r>
            <a:rPr lang="de-DE" sz="700" b="0" kern="1200" dirty="0" err="1"/>
            <a:t>with</a:t>
          </a:r>
          <a:r>
            <a:rPr lang="de-DE" sz="700" b="0" kern="1200" dirty="0"/>
            <a:t> insertion of </a:t>
          </a:r>
          <a:r>
            <a:rPr lang="de-DE" sz="700" b="0" i="1" kern="1200" dirty="0"/>
            <a:t>httA</a:t>
          </a:r>
          <a:r>
            <a:rPr lang="de-DE" sz="700" b="0" kern="1200" dirty="0"/>
            <a:t> and </a:t>
          </a:r>
          <a:r>
            <a:rPr lang="de-DE" sz="700" b="0" i="1" kern="1200" dirty="0"/>
            <a:t>rpl15</a:t>
          </a:r>
          <a:r>
            <a:rPr lang="de-DE" sz="700" b="0" kern="1200" dirty="0"/>
            <a:t> promoters</a:t>
          </a:r>
          <a:endParaRPr lang="en-AU" sz="700" b="0" kern="1200" dirty="0"/>
        </a:p>
      </dsp:txBody>
      <dsp:txXfrm>
        <a:off x="1318736" y="1633740"/>
        <a:ext cx="1122198" cy="595237"/>
      </dsp:txXfrm>
    </dsp:sp>
    <dsp:sp modelId="{59DDA59F-5D9B-4A33-B3F7-956DA4A32AEE}">
      <dsp:nvSpPr>
        <dsp:cNvPr id="0" name=""/>
        <dsp:cNvSpPr/>
      </dsp:nvSpPr>
      <dsp:spPr>
        <a:xfrm>
          <a:off x="1283900" y="3263981"/>
          <a:ext cx="1186600" cy="499498"/>
        </a:xfrm>
        <a:prstGeom prst="round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bg2">
              <a:lumMod val="50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6670" tIns="26670" rIns="26670" bIns="26670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700" b="0" kern="1200" dirty="0"/>
            <a:t>Media optimisation paired to genetic alterations </a:t>
          </a:r>
          <a:endParaRPr lang="en-AU" sz="700" b="0" kern="1200" dirty="0"/>
        </a:p>
      </dsp:txBody>
      <dsp:txXfrm>
        <a:off x="1308283" y="3288364"/>
        <a:ext cx="1137834" cy="450732"/>
      </dsp:txXfrm>
    </dsp:sp>
    <dsp:sp modelId="{D1935EBE-F08B-4A78-A24F-64612CACE637}">
      <dsp:nvSpPr>
        <dsp:cNvPr id="0" name=""/>
        <dsp:cNvSpPr/>
      </dsp:nvSpPr>
      <dsp:spPr>
        <a:xfrm>
          <a:off x="709740" y="4034617"/>
          <a:ext cx="1186600" cy="659639"/>
        </a:xfrm>
        <a:prstGeom prst="round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bg2">
              <a:lumMod val="50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6670" tIns="26670" rIns="26670" bIns="26670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700" b="1" kern="1200" dirty="0"/>
            <a:t>TM44.2 secreting partially hydroxylated collagen</a:t>
          </a:r>
          <a:endParaRPr lang="en-AU" sz="700" b="1" kern="1200" dirty="0"/>
        </a:p>
      </dsp:txBody>
      <dsp:txXfrm>
        <a:off x="741941" y="4066818"/>
        <a:ext cx="1122198" cy="595237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yramid2">
  <dgm:title val=""/>
  <dgm:desc val=""/>
  <dgm:catLst>
    <dgm:cat type="pyramid" pri="3000"/>
    <dgm:cat type="list" pri="21000"/>
    <dgm:cat type="convert" pri="17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 useDef="1">
    <dgm:dataModel>
      <dgm:ptLst/>
      <dgm:bg/>
      <dgm:whole/>
    </dgm:dataModel>
  </dgm:clrData>
  <dgm:layoutNode name="compositeShape">
    <dgm:alg type="composite"/>
    <dgm:shape xmlns:r="http://schemas.openxmlformats.org/officeDocument/2006/relationships" r:blip="">
      <dgm:adjLst/>
    </dgm:shape>
    <dgm:presOf/>
    <dgm:varLst>
      <dgm:dir/>
      <dgm:resizeHandles/>
    </dgm:varLst>
    <dgm:choose name="Name0">
      <dgm:if name="Name1" func="var" arg="dir" op="equ" val="norm">
        <dgm:constrLst>
          <dgm:constr type="w" for="ch" forName="pyramid" refType="h"/>
          <dgm:constr type="h" for="ch" forName="pyramid" refType="h"/>
          <dgm:constr type="h" for="ch" forName="theList" refType="h" fact="0.8"/>
          <dgm:constr type="w" for="ch" forName="theList" refType="h" fact="0.65"/>
          <dgm:constr type="ctrY" for="ch" forName="theList" refType="h" refFor="ch" refForName="pyramid" fact="0.5"/>
          <dgm:constr type="l" for="ch" forName="theList" refType="w" refFor="ch" refForName="pyramid" fact="0.5"/>
          <dgm:constr type="h" for="des" forName="aSpace" refType="h" fact="0.1"/>
        </dgm:constrLst>
      </dgm:if>
      <dgm:else name="Name2">
        <dgm:constrLst>
          <dgm:constr type="w" for="ch" forName="pyramid" refType="h"/>
          <dgm:constr type="h" for="ch" forName="pyramid" refType="h"/>
          <dgm:constr type="h" for="ch" forName="theList" refType="h" fact="0.8"/>
          <dgm:constr type="w" for="ch" forName="theList" refType="h" fact="0.65"/>
          <dgm:constr type="ctrY" for="ch" forName="theList" refType="h" refFor="ch" refForName="pyramid" fact="0.5"/>
          <dgm:constr type="r" for="ch" forName="theList" refType="w" refFor="ch" refForName="pyramid" fact="0.5"/>
          <dgm:constr type="h" for="des" forName="aSpace" refType="h" fact="0.1"/>
        </dgm:constrLst>
      </dgm:else>
    </dgm:choose>
    <dgm:ruleLst/>
    <dgm:choose name="Name3">
      <dgm:if name="Name4" axis="ch" ptType="node" func="cnt" op="gte" val="1">
        <dgm:layoutNode name="pyramid" styleLbl="node1">
          <dgm:alg type="sp"/>
          <dgm:shape xmlns:r="http://schemas.openxmlformats.org/officeDocument/2006/relationships" type="triangle" r:blip="">
            <dgm:adjLst/>
          </dgm:shape>
          <dgm:presOf/>
          <dgm:constrLst/>
          <dgm:ruleLst/>
        </dgm:layoutNode>
        <dgm:layoutNode name="theList">
          <dgm:alg type="lin">
            <dgm:param type="linDir" val="fromT"/>
          </dgm:alg>
          <dgm:shape xmlns:r="http://schemas.openxmlformats.org/officeDocument/2006/relationships" r:blip="">
            <dgm:adjLst/>
          </dgm:shape>
          <dgm:presOf/>
          <dgm:constrLst>
            <dgm:constr type="w" for="ch" forName="aNode" refType="w"/>
            <dgm:constr type="h" for="ch" forName="aNode" refType="h"/>
            <dgm:constr type="primFontSz" for="ch" ptType="node" op="equ"/>
          </dgm:constrLst>
          <dgm:ruleLst/>
          <dgm:forEach name="aNodeForEach" axis="ch" ptType="node">
            <dgm:layoutNode name="aNode" styleLbl="fgAcc1">
              <dgm:varLst>
                <dgm:bulletEnabled val="1"/>
              </dgm:varLst>
              <dgm:alg type="tx"/>
              <dgm:shape xmlns:r="http://schemas.openxmlformats.org/officeDocument/2006/relationships" type="roundRect" r:blip="">
                <dgm:adjLst/>
              </dgm:shape>
              <dgm:presOf axis="desOrSelf" ptType="node"/>
              <dgm:constrLst>
                <dgm:constr type="primFontSz" val="65"/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  <dgm:layoutNode name="a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layoutNode>
      </dgm:if>
      <dgm:else name="Name5"/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214D7A-3916-491A-B857-3216261D1A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B5743CC-3B3D-492F-8D41-35CFAB4945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D0025D-DCD4-4514-8D0D-A194CF122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EB77-8834-4033-9B09-C4792BFECD3D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1655A0-EF2E-46EB-A888-4D413FC5C0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285053-4819-427D-A7CB-F8C10319D3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5506B7-6A7D-4791-982B-386D20E8418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81820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826780-28D1-49EE-9E49-68DA34C094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37E0C1-A6E7-4C27-A08E-0BF36A34E1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BC4D5D-DE7F-4A3F-BD6E-95049A0116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EB77-8834-4033-9B09-C4792BFECD3D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A0D01A-922B-4134-9F55-B66A9E975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4C60F6-4593-468F-B5EB-9874DBB66C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5506B7-6A7D-4791-982B-386D20E8418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02245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1F73E8-122A-4E6E-9B76-2D0CC7125A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7C5214-97E8-4982-A133-D2F0B6EC97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34ED5E-514E-4C8D-8BB9-C34C982AFB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EB77-8834-4033-9B09-C4792BFECD3D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2BAB8F-B64D-4069-9D6F-3A73EA1A1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1A8310-7277-4FA2-94CD-2B07AE017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5506B7-6A7D-4791-982B-386D20E8418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7903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338089-7081-4112-8998-CCFE0BE551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931CCD-48C8-49D0-937A-8B8569520E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6F55CF-3A76-48EB-9F06-6E834ED602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EB77-8834-4033-9B09-C4792BFECD3D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02E11A-B768-4C3F-8A64-AFB45A7046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76FD0C-122E-47DD-8721-D7D58CCAC6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5506B7-6A7D-4791-982B-386D20E8418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127156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C33A7D-DAF3-4B18-8DB4-1DC405CE69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5CF6F9-792F-44C6-98CE-990A0D0759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9FAA73-39ED-43EE-99E0-23B5AE95F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EB77-8834-4033-9B09-C4792BFECD3D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0EF42C-280A-413F-837C-3DEC29AE0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BB7877-7F15-4030-8FC0-5B5870199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5506B7-6A7D-4791-982B-386D20E8418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27237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980BB8-D465-445F-A643-9CD07837BF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534F57-B178-4EBF-8B63-F364CB1401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618F92-E2A6-4108-ADC0-22180A28B0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E9905B-1100-4868-AD07-F4A6CE050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EB77-8834-4033-9B09-C4792BFECD3D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8EB0CE-474B-4893-87A8-CCA6F674E2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40E0E1-0BB0-4DAA-8A4A-B033E62C2A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5506B7-6A7D-4791-982B-386D20E8418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981320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B082C8-E5D7-4601-B0B8-614F4CAC7A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65CE4E-E22D-406E-9B1C-C70A9021CC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7AAFC6-D3A2-495D-A64B-362A75A4F7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593626C-6EAF-4720-8A8F-9264895B3F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3E3C06-3CE4-420B-935A-D23D8F97AD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B586230-C6AE-407D-88BA-2B317E918F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EB77-8834-4033-9B09-C4792BFECD3D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64F7E6-055F-40FE-90A5-E60B066D4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99BB63A-C403-471F-9870-5A52A0584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5506B7-6A7D-4791-982B-386D20E8418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36941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AFA919-CA33-482E-90C1-E4CF8E2890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8FD5800-719F-407B-AAF8-E6132481F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EB77-8834-4033-9B09-C4792BFECD3D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D44D067-8063-4841-978D-6456E4104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69BB098-7454-4063-81EE-745BC29F4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5506B7-6A7D-4791-982B-386D20E8418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18654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58BCFC2-A6A4-4D3F-900E-E6E00D628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EB77-8834-4033-9B09-C4792BFECD3D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14F8801-CC8A-4B0C-BA34-2249C62660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E657B8-EC87-404B-9AEB-7179D1FDF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5506B7-6A7D-4791-982B-386D20E8418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34539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11A8E2-BF0E-4038-A4C7-818B802743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354BA9-1B5A-41CC-AB4F-F74BF8BC35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F8B9FF-28B4-4DD0-9BC1-AEE41C38B5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989811-56D7-417D-8373-37E41CC62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EB77-8834-4033-9B09-C4792BFECD3D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6D3AF8-8776-407A-AB26-D594430A6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2E4D41-725B-47D6-A9B7-ED659CA150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5506B7-6A7D-4791-982B-386D20E8418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43143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A83434-7112-4493-8429-8AC19D84C3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0930E4-1017-46A9-AB6D-CCE7C6E6D3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4FD1BE-ED9E-4804-AEED-EDCE032D46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48E8A8-8720-433E-BEC7-91A7B24C1C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CFEB77-8834-4033-9B09-C4792BFECD3D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3BC76D-3DC0-462F-95D8-62E704534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C1A003-A6DB-4F47-A26F-8BBA001F3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5506B7-6A7D-4791-982B-386D20E8418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21189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6E8EB59-5F04-456A-9622-17C5D324C4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C79BEE-85E3-4460-AEF2-3141DB0625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F66A87-623A-49A5-A723-1CB91C6B39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CFEB77-8834-4033-9B09-C4792BFECD3D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52882-EAE1-4BA8-BE44-812350F7ECC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3988F4-EB3F-4666-898C-C326BA4363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506B7-6A7D-4791-982B-386D20E8418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77292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>
            <a:extLst>
              <a:ext uri="{FF2B5EF4-FFF2-40B4-BE49-F238E27FC236}">
                <a16:creationId xmlns:a16="http://schemas.microsoft.com/office/drawing/2014/main" id="{74559D77-655C-EB68-BD5E-D1AA7273F2D4}"/>
              </a:ext>
            </a:extLst>
          </p:cNvPr>
          <p:cNvGraphicFramePr/>
          <p:nvPr/>
        </p:nvGraphicFramePr>
        <p:xfrm>
          <a:off x="6096000" y="467397"/>
          <a:ext cx="3012140" cy="471039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pSp>
        <p:nvGrpSpPr>
          <p:cNvPr id="5" name="Group 4">
            <a:extLst>
              <a:ext uri="{FF2B5EF4-FFF2-40B4-BE49-F238E27FC236}">
                <a16:creationId xmlns:a16="http://schemas.microsoft.com/office/drawing/2014/main" id="{7E51C620-E2AE-CBBB-34D1-524D9E0642F0}"/>
              </a:ext>
            </a:extLst>
          </p:cNvPr>
          <p:cNvGrpSpPr/>
          <p:nvPr/>
        </p:nvGrpSpPr>
        <p:grpSpPr>
          <a:xfrm>
            <a:off x="6605192" y="664297"/>
            <a:ext cx="1702513" cy="275167"/>
            <a:chOff x="1309626" y="542395"/>
            <a:chExt cx="1702513" cy="550333"/>
          </a:xfrm>
        </p:grpSpPr>
        <p:sp>
          <p:nvSpPr>
            <p:cNvPr id="6" name="Rectangle: Rounded Corners 12">
              <a:extLst>
                <a:ext uri="{FF2B5EF4-FFF2-40B4-BE49-F238E27FC236}">
                  <a16:creationId xmlns:a16="http://schemas.microsoft.com/office/drawing/2014/main" id="{62C5F929-151A-E9D3-DC17-473C05C339FC}"/>
                </a:ext>
              </a:extLst>
            </p:cNvPr>
            <p:cNvSpPr/>
            <p:nvPr/>
          </p:nvSpPr>
          <p:spPr>
            <a:xfrm>
              <a:off x="1309626" y="542395"/>
              <a:ext cx="1702513" cy="550333"/>
            </a:xfrm>
            <a:prstGeom prst="roundRect">
              <a:avLst/>
            </a:prstGeom>
            <a:ln>
              <a:noFill/>
            </a:ln>
          </p:spPr>
          <p:style>
            <a:lnRef idx="2">
              <a:scrgbClr r="0" g="0" b="0"/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endParaRPr lang="en-DE"/>
            </a:p>
          </p:txBody>
        </p:sp>
        <p:sp>
          <p:nvSpPr>
            <p:cNvPr id="7" name="Rectangle: Rounded Corners 4">
              <a:extLst>
                <a:ext uri="{FF2B5EF4-FFF2-40B4-BE49-F238E27FC236}">
                  <a16:creationId xmlns:a16="http://schemas.microsoft.com/office/drawing/2014/main" id="{66E9F737-014C-F1C2-FCA6-E3E3D25673F6}"/>
                </a:ext>
              </a:extLst>
            </p:cNvPr>
            <p:cNvSpPr txBox="1"/>
            <p:nvPr/>
          </p:nvSpPr>
          <p:spPr>
            <a:xfrm>
              <a:off x="1622812" y="569261"/>
              <a:ext cx="1080307" cy="496603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41910" tIns="41910" rIns="41910" bIns="41910" numCol="1" spcCol="1270" anchor="ctr" anchorCtr="0">
              <a:noAutofit/>
            </a:bodyPr>
            <a:lstStyle/>
            <a:p>
              <a:pPr marL="0" lvl="0" indent="0" algn="ctr" defTabSz="4889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de-DE" sz="1100" b="1" i="1" dirty="0"/>
                <a:t>A. niger ∆gaaB</a:t>
              </a:r>
              <a:endParaRPr lang="en-AU" sz="1100" b="1" i="1" kern="1200" dirty="0"/>
            </a:p>
          </p:txBody>
        </p:sp>
      </p:grpSp>
      <p:sp>
        <p:nvSpPr>
          <p:cNvPr id="8" name="Text Box 1">
            <a:extLst>
              <a:ext uri="{FF2B5EF4-FFF2-40B4-BE49-F238E27FC236}">
                <a16:creationId xmlns:a16="http://schemas.microsoft.com/office/drawing/2014/main" id="{D8A3C03A-7FA4-E4CF-C107-5205BB958E14}"/>
              </a:ext>
            </a:extLst>
          </p:cNvPr>
          <p:cNvSpPr txBox="1"/>
          <p:nvPr/>
        </p:nvSpPr>
        <p:spPr>
          <a:xfrm>
            <a:off x="1772020" y="1871179"/>
            <a:ext cx="4638657" cy="2159200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lc="http://schemas.openxmlformats.org/drawingml/2006/lockedCanvas" xmlns:oel="http://schemas.microsoft.com/office/2019/extlst" xmlns:w16cex="http://schemas.microsoft.com/office/word/2018/wordml/cex" xmlns:w16="http://schemas.microsoft.com/office/word/2018/wordml" xmlns:w16sdtdh="http://schemas.microsoft.com/office/word/2020/wordml/sdtdatahash" xmlns:arto="http://schemas.microsoft.com/office/word/2006/arto" xmlns:ma14="http://schemas.microsoft.com/office/mac/drawingml/2011/main" xmlns:w="http://schemas.openxmlformats.org/wordprocessingml/2006/main" xmlns:w10="urn:schemas-microsoft-com:office:word" xmlns:v="urn:schemas-microsoft-com:vml" xmlns:o="urn:schemas-microsoft-com:office:office" xmlns:mv="urn:schemas-microsoft-com:mac:vml" xmlns:mo="http://schemas.microsoft.com/office/mac/office/2008/main" xmlns="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6se="http://schemas.microsoft.com/office/word/2015/wordml/symex" xmlns:w16cid="http://schemas.microsoft.com/office/word/2016/wordml/cid" xmlns:w15="http://schemas.microsoft.com/office/word/2012/wordml" xmlns:w14="http://schemas.microsoft.com/office/word/2010/wordml" xmlns:wp="http://schemas.openxmlformats.org/drawingml/2006/wordprocessingDrawing" xmlns:wp14="http://schemas.microsoft.com/office/word/2010/wordprocessingDrawing" xmlns:m="http://schemas.openxmlformats.org/officeDocument/2006/math" xmlns:am3d="http://schemas.microsoft.com/office/drawing/2017/model3d" xmlns:aink="http://schemas.microsoft.com/office/drawing/2016/ink" xmlns:mc="http://schemas.openxmlformats.org/markup-compatibility/2006" xmlns:cx8="http://schemas.microsoft.com/office/drawing/2016/5/14/chartex" xmlns:cx7="http://schemas.microsoft.com/office/drawing/2016/5/13/chartex" xmlns:cx6="http://schemas.microsoft.com/office/drawing/2016/5/12/chartex" xmlns:cx5="http://schemas.microsoft.com/office/drawing/2016/5/11/chartex" xmlns:cx4="http://schemas.microsoft.com/office/drawing/2016/5/10/chartex" xmlns:cx3="http://schemas.microsoft.com/office/drawing/2016/5/9/chartex" xmlns:cx2="http://schemas.microsoft.com/office/drawing/2015/10/21/chartex" xmlns:cx1="http://schemas.microsoft.com/office/drawing/2015/9/8/chartex" xmlns:cx="http://schemas.microsoft.com/office/drawing/2014/chartex" xmlns:wpc="http://schemas.microsoft.com/office/word/2010/wordprocessingCanvas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endParaRPr lang="en-DE" sz="1200">
              <a:effectLst/>
              <a:latin typeface="Calibri" panose="020F0502020204030204" pitchFamily="34" charset="0"/>
              <a:ea typeface="MS Mincho" panose="02020609040205080304" pitchFamily="49" charset="-128"/>
              <a:cs typeface="Calibri" panose="020F0502020204030204" pitchFamily="34" charset="0"/>
            </a:endParaRPr>
          </a:p>
        </p:txBody>
      </p:sp>
      <p:sp>
        <p:nvSpPr>
          <p:cNvPr id="9" name="Text Box 2">
            <a:extLst>
              <a:ext uri="{FF2B5EF4-FFF2-40B4-BE49-F238E27FC236}">
                <a16:creationId xmlns:a16="http://schemas.microsoft.com/office/drawing/2014/main" id="{059AA7F2-137E-B6F8-D8DE-5E727A9815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62477" y="2546254"/>
            <a:ext cx="4648200" cy="80904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Additional File 10</a:t>
            </a:r>
            <a:r>
              <a:rPr lang="en-US" sz="12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: Schematic of genetic engineering steps to construct the recombinant collagen secreting isolate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A. niger</a:t>
            </a:r>
            <a:r>
              <a:rPr lang="en-US" sz="12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 strain TM44.2</a:t>
            </a: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 </a:t>
            </a:r>
            <a:r>
              <a:rPr lang="en-US" sz="12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from the progenitor strain ∆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gaaB</a:t>
            </a:r>
            <a:r>
              <a:rPr lang="en-US" sz="12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. </a:t>
            </a: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Roman"/>
              </a:rPr>
              <a:t>P4H – prolyl-4 hydroxylase; KO – Knockout.</a:t>
            </a:r>
            <a:endParaRPr lang="en-DE" sz="1200" dirty="0">
              <a:effectLst/>
              <a:latin typeface="Helvetica" pitchFamily="2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35100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MS Mincho</vt:lpstr>
      <vt:lpstr>Arial</vt:lpstr>
      <vt:lpstr>Calibri</vt:lpstr>
      <vt:lpstr>Calibri Light</vt:lpstr>
      <vt:lpstr>Helvetica</vt:lpstr>
      <vt:lpstr>Times New Roman</vt:lpstr>
      <vt:lpstr>Times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.morris</dc:creator>
  <cp:lastModifiedBy>tom.morris</cp:lastModifiedBy>
  <cp:revision>1</cp:revision>
  <dcterms:created xsi:type="dcterms:W3CDTF">2025-07-16T07:43:09Z</dcterms:created>
  <dcterms:modified xsi:type="dcterms:W3CDTF">2025-07-16T07:44:02Z</dcterms:modified>
</cp:coreProperties>
</file>